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4" d="100"/>
          <a:sy n="74" d="100"/>
        </p:scale>
        <p:origin x="84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38BEC8-3E5B-4CA5-9CAE-28C44ABF91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D3CA6B-3A6F-4FE1-A89D-27EF32C5A8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E4E030-9605-463F-B816-8F3864177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E76B10-015E-43F6-A3AC-2140EA07A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3C3A8F-47B3-4ABF-9FFE-90A9E74503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90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DD7F76-CA83-4A01-92D2-F464FD6EF7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5EA36C-69BE-4944-A6D6-40DC2DE066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DC8665-A40B-4045-9CAA-42A2985A8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0D8991-187A-4966-8D24-0A57B8B0A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4626E1-4414-4E4D-BDFE-03C03B48D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697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99250B5-6BD9-4436-A960-85F2D167A9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364128-9232-4F69-8DDE-2DDB71A618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C0224F-C078-488F-BE60-1A92ED636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56CBD2-4F75-4FCC-B09C-41CD18E26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A5F57F-C4B2-4F4B-8557-A8E09E4BA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596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8BF31-86B2-4789-BFB2-3A51BDD3E5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219765-6C13-4403-A763-37277DC68A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FB6005-2DAB-45D2-8F4F-EF369F016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7C48CF-0DD7-4784-BDCD-2AD585E6C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3C16D4-3211-4087-8E27-995EC4A4D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321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46260B-263C-4E77-BA7D-7F5E689B23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B1AF7C-35BD-4518-9CA7-B0D492C410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F8AA9A-073D-49EB-BF1F-9A21DD3B8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C0A0A9-197B-4850-BBF0-D24AC4717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7E1CE1-FD03-4EA8-85A0-89A1CE772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729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E27B39-F675-49D2-926A-CA9FE7505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D89468-56D3-46AF-A1C4-4C824FC339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E63F0F-230D-4A1E-9DE5-26B7F5C62F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B2DA8F-C9DC-4E8D-BD6A-8B63E89A7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B40DCB-F772-4F0C-93D9-4A76016DD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4C7801-6D5C-4449-ACA5-D7CF7FCF4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410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3B1EE8-6F4C-45F0-993D-C117C2D79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F3AAF6-30A5-4A3C-BABA-74B2AC2B70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172E65-7381-43F0-B7B9-0FFA8D903F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A90EA10-4F8F-47AF-80C7-05777B200B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B5CA3B0-21BD-4372-B54F-EBC5D47C16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02979BA-A57D-42AA-A196-E634C28DA3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C814C93-E644-4483-9876-89BF04593B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F647ADB-12F8-457B-A68F-092E07B10F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622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17FBBE-9EA9-4717-9539-A39BE59AFB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92DEE5-B15F-4A2B-AF17-6515EE9C6A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C5F62D-E026-4106-9E9D-17776D62A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1F1A84-0401-4BBC-B428-AE3A58D47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256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8FEB9C5-6958-4D13-B017-A1DE1BA73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30716C-2299-4E30-AC14-51AE50781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1D513B-35F2-44BD-899B-522E7910E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704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D8435E-A722-4228-9553-FA66662088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3C8F7A-E33B-4B04-9D9F-2921A97F6D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7AA621-6526-40F9-B5D8-D29967AB39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0896E5-3227-4163-8C14-6F8A7DF8E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54A180-897B-4816-8853-6DBE39A73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913A30-131E-4D53-BED5-9EB15DA20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1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1135C2-6681-4ACA-ADD4-629E70A7FE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8CD99A-DB08-42C4-B5AD-DAD2C50CE9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C1181A-D852-4453-929F-10EABE0085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51D9B8-856F-40CA-AA4B-7F6E92B03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59A1F8-4940-4B3D-9989-2E42CACDC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3EC62D-BD0D-4B6F-A7FE-D4C4D9D87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264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D214B47-CD78-4B5F-B89C-7EC65F1EAC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133653-4F4D-47A3-97E9-24FA02F593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BD1197-00E1-4EB9-9ACD-7411EDA5A8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01EDE-71F8-41BA-AE3B-B959B42CD8CE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185F70-25D8-47DF-B8A2-FF65BDD6C0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F3FBD1-31B5-455C-B62C-1DF46CA508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1AB5DB-A9DD-4FB0-A8ED-7A53E99841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806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4438E6F-EC09-4196-8CB9-B16B5EC3EC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8834616"/>
              </p:ext>
            </p:extLst>
          </p:nvPr>
        </p:nvGraphicFramePr>
        <p:xfrm>
          <a:off x="1144878" y="779228"/>
          <a:ext cx="9055191" cy="48874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73865">
                  <a:extLst>
                    <a:ext uri="{9D8B030D-6E8A-4147-A177-3AD203B41FA5}">
                      <a16:colId xmlns:a16="http://schemas.microsoft.com/office/drawing/2014/main" val="1282945419"/>
                    </a:ext>
                  </a:extLst>
                </a:gridCol>
                <a:gridCol w="1642665">
                  <a:extLst>
                    <a:ext uri="{9D8B030D-6E8A-4147-A177-3AD203B41FA5}">
                      <a16:colId xmlns:a16="http://schemas.microsoft.com/office/drawing/2014/main" val="3174051436"/>
                    </a:ext>
                  </a:extLst>
                </a:gridCol>
                <a:gridCol w="1375732">
                  <a:extLst>
                    <a:ext uri="{9D8B030D-6E8A-4147-A177-3AD203B41FA5}">
                      <a16:colId xmlns:a16="http://schemas.microsoft.com/office/drawing/2014/main" val="2280438779"/>
                    </a:ext>
                  </a:extLst>
                </a:gridCol>
                <a:gridCol w="2443464">
                  <a:extLst>
                    <a:ext uri="{9D8B030D-6E8A-4147-A177-3AD203B41FA5}">
                      <a16:colId xmlns:a16="http://schemas.microsoft.com/office/drawing/2014/main" val="2085161221"/>
                    </a:ext>
                  </a:extLst>
                </a:gridCol>
                <a:gridCol w="1519465">
                  <a:extLst>
                    <a:ext uri="{9D8B030D-6E8A-4147-A177-3AD203B41FA5}">
                      <a16:colId xmlns:a16="http://schemas.microsoft.com/office/drawing/2014/main" val="1312427684"/>
                    </a:ext>
                  </a:extLst>
                </a:gridCol>
              </a:tblGrid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atient Sampl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Sex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Ag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Rac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 Patient #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93161935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90131026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Fe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African Americ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93754421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90201000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Femal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African Americ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65605331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90201002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aucasi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08914396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90212014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African Americ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67733798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90201002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Fe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aucasi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16206336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81016015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aucasi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9240398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90201001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aucasi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59564776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80216019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aucasi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67300989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81106005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Fe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African Americ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13400977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90212014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African Americ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79731207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9011801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Fe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aucasi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1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00256569"/>
                  </a:ext>
                </a:extLst>
              </a:tr>
              <a:tr h="375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81116015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Femal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Caucasi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P1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073812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51483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Widescreen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darai, Shirin R</dc:creator>
  <cp:lastModifiedBy>Modarai, Shirin R</cp:lastModifiedBy>
  <cp:revision>1</cp:revision>
  <dcterms:created xsi:type="dcterms:W3CDTF">2020-08-05T16:58:47Z</dcterms:created>
  <dcterms:modified xsi:type="dcterms:W3CDTF">2020-08-05T16:59:45Z</dcterms:modified>
</cp:coreProperties>
</file>